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0" r:id="rId3"/>
    <p:sldId id="262" r:id="rId4"/>
    <p:sldId id="282" r:id="rId5"/>
    <p:sldId id="271" r:id="rId6"/>
    <p:sldId id="272" r:id="rId7"/>
    <p:sldId id="273" r:id="rId8"/>
    <p:sldId id="274" r:id="rId9"/>
    <p:sldId id="275" r:id="rId10"/>
    <p:sldId id="276" r:id="rId11"/>
    <p:sldId id="277" r:id="rId12"/>
    <p:sldId id="278" r:id="rId13"/>
    <p:sldId id="279" r:id="rId14"/>
    <p:sldId id="281" r:id="rId15"/>
    <p:sldId id="280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95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02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7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8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9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12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1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8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23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72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8B0EF-3C06-4365-85ED-831195B7F133}" type="datetimeFigureOut">
              <a:rPr lang="en-US" smtClean="0"/>
              <a:t>6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3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tripdatabase.com/" TargetMode="External"/><Relationship Id="rId7" Type="http://schemas.openxmlformats.org/officeDocument/2006/relationships/image" Target="../media/image14.png"/><Relationship Id="rId2" Type="http://schemas.openxmlformats.org/officeDocument/2006/relationships/hyperlink" Target="https://pubmed.ncbi.nlm.nih.gov/" TargetMode="Externa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hyperlink" Target="https://www.cochranelibrary.com/advanced-search" TargetMode="Externa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ar-SY" sz="4800" dirty="0">
                <a:solidFill>
                  <a:schemeClr val="accent2">
                    <a:lumMod val="50000"/>
                  </a:schemeClr>
                </a:solidFill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طب المسند بالدليل في ظروف العمل السريري</a:t>
            </a:r>
            <a:endParaRPr lang="en-US" sz="4800" dirty="0">
              <a:solidFill>
                <a:schemeClr val="accent2">
                  <a:lumMod val="50000"/>
                </a:schemeClr>
              </a:solidFill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rtl="1"/>
            <a:r>
              <a:rPr lang="ar-SY" sz="5400" dirty="0">
                <a:solidFill>
                  <a:schemeClr val="accent3">
                    <a:lumMod val="75000"/>
                  </a:schemeClr>
                </a:solidFill>
              </a:rPr>
              <a:t>الوحدة الثانية</a:t>
            </a:r>
          </a:p>
          <a:p>
            <a:r>
              <a:rPr lang="ar-SY" sz="3200" dirty="0"/>
              <a:t>كيفية البحث في الأدب الطبي</a:t>
            </a:r>
            <a:endParaRPr lang="en-US" sz="3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8748"/>
            <a:ext cx="2479677" cy="19634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5382" y="799197"/>
            <a:ext cx="432261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جامعة الافتراضية السورية</a:t>
            </a:r>
          </a:p>
          <a:p>
            <a:pPr algn="r" rtl="1"/>
            <a:endParaRPr lang="ar-SY" sz="2000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ماجستير التعليم الطبي</a:t>
            </a:r>
            <a:endParaRPr lang="en-US" sz="2800" b="1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36183" y="5349873"/>
            <a:ext cx="173181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r-SY" sz="2800" dirty="0"/>
              <a:t>إعداد وتقديم:</a:t>
            </a:r>
            <a:br>
              <a:rPr lang="ar-SY" sz="2800" dirty="0"/>
            </a:br>
            <a:r>
              <a:rPr lang="ar-SY" sz="2800" dirty="0"/>
              <a:t>يزن قنجراوي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0" y="5351891"/>
            <a:ext cx="233108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ar-SY" sz="2800" dirty="0"/>
              <a:t>بإشراف:</a:t>
            </a:r>
            <a:br>
              <a:rPr lang="ar-SY" sz="2800" dirty="0"/>
            </a:br>
            <a:r>
              <a:rPr lang="ar-SY" sz="2800" dirty="0"/>
              <a:t>أ. د. ميسون دشاش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677004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95A3D1-CD0E-49C3-82CF-7A0B25D0C6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517984-25DD-4F3E-AB66-5D6B35D58B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dirty="0"/>
              <a:t>العبارات</a:t>
            </a:r>
          </a:p>
          <a:p>
            <a:pPr algn="just" rtl="1"/>
            <a:r>
              <a:rPr lang="ar-SY" dirty="0"/>
              <a:t>إذا كان لديك كلمتان أو أكثر يجب أن تظهر بترتيب معين ، فضعها بين علامات اقتباس.</a:t>
            </a:r>
          </a:p>
          <a:p>
            <a:pPr algn="just" rtl="1"/>
            <a:r>
              <a:rPr lang="ar-SY" dirty="0"/>
              <a:t>"هذه عبارة" تخبر علامات الاقتباس البحث للعثور على الكلمات بهذا الترتيب المحدد، وليست مبعثرة في جميع أنحاء النص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</a:t>
            </a:r>
            <a:r>
              <a:rPr lang="en-US" sz="2000" i="1" dirty="0">
                <a:solidFill>
                  <a:prstClr val="black"/>
                </a:solidFill>
              </a:rPr>
              <a:t>PICO Searching</a:t>
            </a:r>
            <a:r>
              <a:rPr lang="en-US" sz="2000" dirty="0">
                <a:solidFill>
                  <a:prstClr val="black"/>
                </a:solidFill>
              </a:rPr>
              <a:t>, 2021)</a:t>
            </a:r>
            <a:endParaRPr lang="ar-SY" sz="2000" dirty="0">
              <a:solidFill>
                <a:prstClr val="black"/>
              </a:solidFill>
            </a:endParaRP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0A3850A-AEC0-4A16-93EA-A6D41241B7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4393994"/>
            <a:ext cx="6524491" cy="1782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897262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00A099-DB2C-49FA-941E-2D5050BF6A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E7615F-68ED-48FF-9883-B14C579AC6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Y" sz="3600" dirty="0"/>
              <a:t>الأقواس</a:t>
            </a:r>
            <a:endParaRPr lang="ar-SY" dirty="0"/>
          </a:p>
          <a:p>
            <a:pPr algn="just" rtl="1"/>
            <a:r>
              <a:rPr lang="ar-SY" dirty="0"/>
              <a:t>تعمل الأقواس بنفس الطريقة التي تعمل بها المعادلات الرياضية</a:t>
            </a:r>
          </a:p>
          <a:p>
            <a:pPr algn="just" rtl="1"/>
            <a:r>
              <a:rPr lang="ar-SY" dirty="0"/>
              <a:t>جميع المرادفات لعنصر واحد من عناصر البحث</a:t>
            </a:r>
          </a:p>
          <a:p>
            <a:pPr algn="just" rtl="1"/>
            <a:r>
              <a:rPr lang="ar-SY" dirty="0"/>
              <a:t>ثم استرداد المقالات التي تذكر جميع عناصر</a:t>
            </a:r>
            <a:r>
              <a:rPr lang="en-US" dirty="0"/>
              <a:t>PICO </a:t>
            </a:r>
            <a:r>
              <a:rPr lang="ar-SY" dirty="0"/>
              <a:t> الأربعة </a:t>
            </a:r>
          </a:p>
          <a:p>
            <a:pPr algn="just" rtl="1"/>
            <a:r>
              <a:rPr lang="ar-SY" dirty="0"/>
              <a:t>مثال: (سرطان الثدي أو ورم خبيث في الثدي) و (عشر سنوات أو عقد زمني) 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</a:t>
            </a:r>
            <a:r>
              <a:rPr lang="en-US" sz="2000" i="1" dirty="0">
                <a:solidFill>
                  <a:prstClr val="black"/>
                </a:solidFill>
              </a:rPr>
              <a:t>PICO Searching</a:t>
            </a:r>
            <a:r>
              <a:rPr lang="en-US" sz="2000" dirty="0">
                <a:solidFill>
                  <a:prstClr val="black"/>
                </a:solidFill>
              </a:rPr>
              <a:t>, 2021)</a:t>
            </a:r>
            <a:endParaRPr lang="ar-SY" sz="2000" dirty="0">
              <a:solidFill>
                <a:prstClr val="black"/>
              </a:solidFill>
            </a:endParaRPr>
          </a:p>
          <a:p>
            <a:pPr algn="just" rtl="1"/>
            <a:endParaRPr lang="ar-SY" dirty="0"/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521C5133-FBD8-418E-B6CD-226377B5227A}"/>
              </a:ext>
            </a:extLst>
          </p:cNvPr>
          <p:cNvSpPr/>
          <p:nvPr/>
        </p:nvSpPr>
        <p:spPr>
          <a:xfrm>
            <a:off x="0" y="4515729"/>
            <a:ext cx="9973994" cy="1076813"/>
          </a:xfrm>
          <a:prstGeom prst="round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sz="3600" b="1" dirty="0"/>
              <a:t>(Breast cancer OR malignant tumor in the Breast) </a:t>
            </a:r>
          </a:p>
          <a:p>
            <a:pPr algn="ctr"/>
            <a:r>
              <a:rPr lang="en-US" sz="3600" b="1" dirty="0"/>
              <a:t>AND (Ten years OR decade)</a:t>
            </a:r>
            <a:endParaRPr lang="ar-SY" sz="3600" b="1" dirty="0"/>
          </a:p>
        </p:txBody>
      </p:sp>
    </p:spTree>
    <p:extLst>
      <p:ext uri="{BB962C8B-B14F-4D97-AF65-F5344CB8AC3E}">
        <p14:creationId xmlns:p14="http://schemas.microsoft.com/office/powerpoint/2010/main" val="30527347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F383B8-E217-4D81-B52D-9AE8426F73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474153-A16F-4349-846A-9EE801F1F1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Y" sz="3600" dirty="0"/>
              <a:t>قواعد بسيطة للبحث</a:t>
            </a:r>
          </a:p>
          <a:p>
            <a:pPr algn="just" rtl="1"/>
            <a:r>
              <a:rPr lang="ar-SY" dirty="0"/>
              <a:t>قم بإنشاء مخطط كلمات المفتاحية والمرادفات لـ </a:t>
            </a:r>
            <a:r>
              <a:rPr lang="en-US" dirty="0"/>
              <a:t>PICO</a:t>
            </a:r>
            <a:endParaRPr lang="ar-SY" dirty="0"/>
          </a:p>
          <a:p>
            <a:pPr algn="just" rtl="1"/>
            <a:r>
              <a:rPr lang="ar-SY" dirty="0"/>
              <a:t>يتم دمج جميع المرادفات الموجودة في عمود مع </a:t>
            </a:r>
            <a:r>
              <a:rPr lang="en-US" dirty="0"/>
              <a:t>OR</a:t>
            </a:r>
          </a:p>
          <a:p>
            <a:pPr algn="just" rtl="1"/>
            <a:r>
              <a:rPr lang="ar-SY" dirty="0"/>
              <a:t>للجمع بين الأعمدة </a:t>
            </a:r>
            <a:r>
              <a:rPr lang="en-US" dirty="0"/>
              <a:t>AND</a:t>
            </a:r>
          </a:p>
          <a:p>
            <a:pPr algn="just" rtl="1"/>
            <a:r>
              <a:rPr lang="ar-SY" dirty="0"/>
              <a:t>يجب أن تحتوي المرادفات </a:t>
            </a:r>
            <a:r>
              <a:rPr lang="en-US" dirty="0"/>
              <a:t>OR</a:t>
            </a:r>
            <a:r>
              <a:rPr lang="ar-SY" dirty="0"/>
              <a:t> على أقواس حولها.</a:t>
            </a:r>
          </a:p>
          <a:p>
            <a:pPr marL="0" indent="0" algn="just" rtl="1">
              <a:buNone/>
            </a:pPr>
            <a:endParaRPr lang="ar-SY" dirty="0"/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</a:t>
            </a:r>
            <a:r>
              <a:rPr lang="en-US" sz="2000" i="1" dirty="0">
                <a:solidFill>
                  <a:prstClr val="black"/>
                </a:solidFill>
              </a:rPr>
              <a:t>PICO Searching</a:t>
            </a:r>
            <a:r>
              <a:rPr lang="en-US" sz="2000" dirty="0">
                <a:solidFill>
                  <a:prstClr val="black"/>
                </a:solidFill>
              </a:rPr>
              <a:t>, 2021)</a:t>
            </a:r>
            <a:endParaRPr lang="ar-SY" sz="2000" dirty="0">
              <a:solidFill>
                <a:prstClr val="black"/>
              </a:solidFill>
            </a:endParaRPr>
          </a:p>
          <a:p>
            <a:pPr algn="just" rtl="1"/>
            <a:endParaRPr lang="ar-SY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87D3CE89-4444-4167-B285-88454400E1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501663"/>
            <a:ext cx="7553374" cy="2356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335899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B9629-DDFB-4926-8C80-69A2CA1D55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59EFCF-9DD3-4D76-B004-B811FC5515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algn="just" rtl="1"/>
            <a:r>
              <a:rPr lang="ar-SY" sz="4700" dirty="0"/>
              <a:t>محركات البحث الطبية</a:t>
            </a:r>
            <a:r>
              <a:rPr lang="ar-SY" sz="4200" dirty="0"/>
              <a:t>:</a:t>
            </a:r>
          </a:p>
          <a:p>
            <a:pPr algn="just" rtl="1"/>
            <a:r>
              <a:rPr lang="en-US" dirty="0">
                <a:hlinkClick r:id="rId2"/>
              </a:rPr>
              <a:t>PubMed</a:t>
            </a:r>
            <a:endParaRPr lang="ar-SY" dirty="0"/>
          </a:p>
          <a:p>
            <a:pPr marL="0" lvl="0" indent="0" algn="just" rtl="1">
              <a:buNone/>
            </a:pPr>
            <a:r>
              <a:rPr lang="ar-SY" dirty="0"/>
              <a:t>مقالات في مجلات الطب والتمريض </a:t>
            </a:r>
          </a:p>
          <a:p>
            <a:pPr marL="0" lvl="0" indent="0" algn="just" rtl="1">
              <a:buNone/>
            </a:pPr>
            <a:r>
              <a:rPr lang="ar-SY" dirty="0"/>
              <a:t>وطب الأسنان والمجالات الصحية الأخرى. </a:t>
            </a:r>
          </a:p>
          <a:p>
            <a:pPr algn="just" rtl="1"/>
            <a:r>
              <a:rPr lang="en-US" dirty="0">
                <a:hlinkClick r:id="rId3"/>
              </a:rPr>
              <a:t>TRIP</a:t>
            </a:r>
            <a:endParaRPr lang="en-US" dirty="0"/>
          </a:p>
          <a:p>
            <a:pPr marL="0" indent="0" algn="just" rtl="1">
              <a:buNone/>
            </a:pPr>
            <a:r>
              <a:rPr lang="ar-SY" dirty="0"/>
              <a:t>محرك بحث سريري </a:t>
            </a:r>
            <a:r>
              <a:rPr lang="en-US" sz="2000" dirty="0"/>
              <a:t>(</a:t>
            </a:r>
            <a:r>
              <a:rPr lang="en-US" sz="2000" i="1" dirty="0"/>
              <a:t>PICO Searching</a:t>
            </a:r>
            <a:r>
              <a:rPr lang="en-US" sz="2000" dirty="0"/>
              <a:t>, 2021)</a:t>
            </a:r>
            <a:endParaRPr lang="ar-SY" sz="2000" dirty="0"/>
          </a:p>
          <a:p>
            <a:pPr algn="just" rtl="1"/>
            <a:r>
              <a:rPr lang="ar-SY" dirty="0"/>
              <a:t>مكتبة </a:t>
            </a:r>
            <a:r>
              <a:rPr lang="ar-SY" dirty="0">
                <a:hlinkClick r:id="rId4"/>
              </a:rPr>
              <a:t>كوكرين</a:t>
            </a:r>
            <a:r>
              <a:rPr lang="ar-SY" dirty="0"/>
              <a:t>:</a:t>
            </a:r>
          </a:p>
          <a:p>
            <a:pPr marL="0" indent="0" algn="just" rtl="1">
              <a:buNone/>
            </a:pPr>
            <a:r>
              <a:rPr lang="ar-SY" dirty="0"/>
              <a:t>على مراجعات منهجية حول فعالية تدخلات الرعاية الصحية</a:t>
            </a:r>
          </a:p>
          <a:p>
            <a:pPr marL="0" indent="0" algn="just" rtl="1">
              <a:buNone/>
            </a:pPr>
            <a:r>
              <a:rPr lang="en-US" sz="2000" dirty="0"/>
              <a:t>(</a:t>
            </a:r>
            <a:r>
              <a:rPr lang="en-US" sz="2000" dirty="0" err="1"/>
              <a:t>DiCenso</a:t>
            </a:r>
            <a:r>
              <a:rPr lang="en-US" sz="2000" dirty="0"/>
              <a:t> et al., 2009)</a:t>
            </a:r>
            <a:endParaRPr lang="ar-SY" sz="2000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13507FA-13A3-4FA3-997C-543766F99E8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41" y="3060465"/>
            <a:ext cx="2840168" cy="182815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C2A474F-F30E-4A70-B7AF-F2292B0FDC0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4609" y="2189267"/>
            <a:ext cx="4057650" cy="112395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DACEBB5-4D75-4864-A80D-A95E220FE28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2557" y="3676859"/>
            <a:ext cx="2943332" cy="2943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832685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6945283-9E40-4A0E-AC3C-33A849ED5B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4259" y="577703"/>
            <a:ext cx="8703481" cy="57025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348738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221CA-B4C6-4B96-856C-455272473D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مراجع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D84603-A634-4D9C-8D13-B68575CA06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 err="1"/>
              <a:t>DiCenso</a:t>
            </a:r>
            <a:r>
              <a:rPr lang="en-US" dirty="0"/>
              <a:t>, A., Bayley, L., &amp; Haynes, B. (2009). Accessing pre-appraised evidence: Fine-tuning the 5S model into a 6S model. </a:t>
            </a:r>
            <a:r>
              <a:rPr lang="en-US" i="1" dirty="0"/>
              <a:t>Evidence-Based Nursing</a:t>
            </a:r>
            <a:r>
              <a:rPr lang="en-US" dirty="0"/>
              <a:t>, </a:t>
            </a:r>
            <a:r>
              <a:rPr lang="en-US" i="1" dirty="0"/>
              <a:t>12</a:t>
            </a:r>
            <a:r>
              <a:rPr lang="en-US" dirty="0"/>
              <a:t>(4), 99–101. https://doi.org/10.1136/ebn.12.4.99-b</a:t>
            </a:r>
          </a:p>
          <a:p>
            <a:r>
              <a:rPr lang="en-US" dirty="0" err="1"/>
              <a:t>Eady</a:t>
            </a:r>
            <a:r>
              <a:rPr lang="en-US" dirty="0"/>
              <a:t>, A., </a:t>
            </a:r>
            <a:r>
              <a:rPr lang="en-US" dirty="0" err="1"/>
              <a:t>Glasziou</a:t>
            </a:r>
            <a:r>
              <a:rPr lang="en-US" dirty="0"/>
              <a:t>, P., &amp; Haynes, B. (2008). Less is more: Where do the abstracts in the EBM journal come from? </a:t>
            </a:r>
            <a:r>
              <a:rPr lang="en-US" i="1" dirty="0"/>
              <a:t>Evidence-Based Medicine</a:t>
            </a:r>
            <a:r>
              <a:rPr lang="en-US" dirty="0"/>
              <a:t>, </a:t>
            </a:r>
            <a:r>
              <a:rPr lang="en-US" i="1" dirty="0"/>
              <a:t>13</a:t>
            </a:r>
            <a:r>
              <a:rPr lang="en-US" dirty="0"/>
              <a:t>(1), 3. https://doi.org/10.1136/ebm.13.1.3</a:t>
            </a:r>
            <a:endParaRPr lang="en-US" i="1" dirty="0"/>
          </a:p>
          <a:p>
            <a:r>
              <a:rPr lang="en-US" i="1" dirty="0"/>
              <a:t>PICO Searching</a:t>
            </a:r>
            <a:r>
              <a:rPr lang="en-US" dirty="0"/>
              <a:t>. (2021). San Diego State University, Library. https://libguides.sdsu.edu/c.php?g=666361&amp;p=4686833</a:t>
            </a:r>
          </a:p>
          <a:p>
            <a:r>
              <a:rPr lang="en-US" dirty="0" err="1"/>
              <a:t>Glasziou</a:t>
            </a:r>
            <a:r>
              <a:rPr lang="en-US" dirty="0"/>
              <a:t>, P., Burls, A., &amp; Gilbert, R. (2008). Evidence based medicine and the medical curriculum. </a:t>
            </a:r>
            <a:r>
              <a:rPr lang="en-US" i="1" dirty="0" err="1"/>
              <a:t>Bmj</a:t>
            </a:r>
            <a:r>
              <a:rPr lang="en-US" dirty="0"/>
              <a:t>, </a:t>
            </a:r>
            <a:r>
              <a:rPr lang="en-US" i="1" dirty="0"/>
              <a:t>337</a:t>
            </a:r>
            <a:r>
              <a:rPr lang="en-US" dirty="0"/>
              <a:t>(7672), 704–705. https://doi.org/10.1136/bmj.a1253</a:t>
            </a:r>
          </a:p>
          <a:p>
            <a:endParaRPr lang="ar-SY" dirty="0"/>
          </a:p>
        </p:txBody>
      </p:sp>
    </p:spTree>
    <p:extLst>
      <p:ext uri="{BB962C8B-B14F-4D97-AF65-F5344CB8AC3E}">
        <p14:creationId xmlns:p14="http://schemas.microsoft.com/office/powerpoint/2010/main" val="682498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أهداف التعليمية: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r" rtl="1"/>
            <a:r>
              <a:rPr lang="ar-SY" sz="3600" dirty="0"/>
              <a:t>عند الانتهاء من هذه الوحدة ستكون قادر على:</a:t>
            </a:r>
          </a:p>
          <a:p>
            <a:pPr marL="0" indent="0" algn="r" rtl="1">
              <a:buNone/>
            </a:pPr>
            <a:endParaRPr lang="ar-SY" sz="3600" dirty="0"/>
          </a:p>
          <a:p>
            <a:pPr algn="r" rtl="1"/>
            <a:r>
              <a:rPr lang="ar-SY" dirty="0"/>
              <a:t>1) </a:t>
            </a:r>
            <a:r>
              <a:rPr lang="ar-SA" dirty="0"/>
              <a:t>تحويل المشكلة السريرية إلى سؤال.</a:t>
            </a:r>
          </a:p>
          <a:p>
            <a:pPr marL="0" indent="0" algn="r" rtl="1">
              <a:buNone/>
            </a:pPr>
            <a:endParaRPr lang="en-US" dirty="0"/>
          </a:p>
          <a:p>
            <a:pPr algn="r" rtl="1"/>
            <a:r>
              <a:rPr lang="ar-SY" dirty="0"/>
              <a:t>2) </a:t>
            </a:r>
            <a:r>
              <a:rPr lang="ar-SA" b="1" dirty="0"/>
              <a:t>البحث في محركات البحث الطبية.</a:t>
            </a:r>
            <a:endParaRPr lang="en-US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15803"/>
            <a:ext cx="4164042" cy="2770981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1504774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4E7B10-3866-4869-B324-CA0315BF8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228E4C-D3F3-4F4D-842B-C23377BE22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>
              <a:lnSpc>
                <a:spcPct val="100000"/>
              </a:lnSpc>
            </a:pPr>
            <a:r>
              <a:rPr lang="ar-SY" sz="3600" dirty="0"/>
              <a:t>أهمية تعلم هذه المهارة:</a:t>
            </a:r>
          </a:p>
          <a:p>
            <a:pPr algn="just" rtl="1">
              <a:lnSpc>
                <a:spcPct val="100000"/>
              </a:lnSpc>
            </a:pPr>
            <a:r>
              <a:rPr lang="ar-SY" dirty="0"/>
              <a:t>لا يمكن للممارسين السريريين اليوم الاعتماد فقط على ما تعلموه. </a:t>
            </a:r>
            <a:r>
              <a:rPr lang="en-US" sz="2000" dirty="0"/>
              <a:t>(Choudhry et al., 2005)</a:t>
            </a:r>
            <a:endParaRPr lang="ar-SY" dirty="0"/>
          </a:p>
          <a:p>
            <a:pPr algn="just" rtl="1">
              <a:lnSpc>
                <a:spcPct val="100000"/>
              </a:lnSpc>
            </a:pPr>
            <a:r>
              <a:rPr lang="ar-SY" dirty="0"/>
              <a:t>المعرفة حول الأمراض والتشخيص والعلاج الفعال تنمو بسرعة. </a:t>
            </a:r>
            <a:r>
              <a:rPr lang="en-US" sz="2000" dirty="0"/>
              <a:t>(</a:t>
            </a:r>
            <a:r>
              <a:rPr lang="en-US" sz="2000" dirty="0" err="1"/>
              <a:t>Glasziou</a:t>
            </a:r>
            <a:r>
              <a:rPr lang="en-US" sz="2000" dirty="0"/>
              <a:t> et al., 2008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A01E9ED-7373-42DC-9510-306AA467CF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4955831"/>
            <a:ext cx="3610122" cy="19021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A30C6C2-3733-4DE7-943F-13B6363A3D6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88242" y="3878480"/>
            <a:ext cx="1650412" cy="1650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66611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BA0F9F-8AF3-4D92-9AC3-5FA204023E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0436B4-786D-4D64-BD50-D6D2A84DDC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>
              <a:lnSpc>
                <a:spcPct val="100000"/>
              </a:lnSpc>
            </a:pPr>
            <a:r>
              <a:rPr lang="ar-SY" sz="3600" dirty="0"/>
              <a:t>أهمية تعلم هذه المهارة:</a:t>
            </a:r>
          </a:p>
          <a:p>
            <a:pPr algn="just" rtl="1">
              <a:lnSpc>
                <a:spcPct val="100000"/>
              </a:lnSpc>
            </a:pPr>
            <a:r>
              <a:rPr lang="ar-SY" dirty="0"/>
              <a:t>يجب أن يكون الالتزام بالتعلم مدى الحياة جزءًا لا يتجزأ من الممارسة المهنية الأخلاقية. تتم إضافة أكثر من </a:t>
            </a:r>
            <a:r>
              <a:rPr lang="ar-SY" dirty="0">
                <a:solidFill>
                  <a:srgbClr val="FF0000"/>
                </a:solidFill>
              </a:rPr>
              <a:t>2000</a:t>
            </a:r>
            <a:r>
              <a:rPr lang="ar-SY" dirty="0"/>
              <a:t> ورقة بحثية جديدة إلى </a:t>
            </a:r>
            <a:r>
              <a:rPr lang="en-US" dirty="0"/>
              <a:t>Medline</a:t>
            </a:r>
            <a:r>
              <a:rPr lang="ar-SY" dirty="0"/>
              <a:t> كل يوم </a:t>
            </a:r>
            <a:r>
              <a:rPr lang="en-US" sz="2000" dirty="0"/>
              <a:t>(</a:t>
            </a:r>
            <a:r>
              <a:rPr lang="en-US" sz="2000" dirty="0" err="1"/>
              <a:t>Eady</a:t>
            </a:r>
            <a:r>
              <a:rPr lang="en-US" sz="2000" dirty="0"/>
              <a:t> et al., 2008)</a:t>
            </a:r>
          </a:p>
          <a:p>
            <a:pPr algn="just" rtl="1">
              <a:lnSpc>
                <a:spcPct val="100000"/>
              </a:lnSpc>
            </a:pPr>
            <a:r>
              <a:rPr lang="ar-SY" dirty="0"/>
              <a:t>"أصبح محرك البحث الآن ضروريًا مثل </a:t>
            </a:r>
            <a:r>
              <a:rPr lang="ar-SY" dirty="0">
                <a:solidFill>
                  <a:srgbClr val="FF0000"/>
                </a:solidFill>
              </a:rPr>
              <a:t>سماعة الطبيب</a:t>
            </a:r>
            <a:r>
              <a:rPr lang="ar-SY" dirty="0"/>
              <a:t>" </a:t>
            </a:r>
            <a:r>
              <a:rPr lang="en-US" sz="2000" dirty="0"/>
              <a:t>(</a:t>
            </a:r>
            <a:r>
              <a:rPr lang="en-US" sz="2000" dirty="0" err="1"/>
              <a:t>Glasziou</a:t>
            </a:r>
            <a:r>
              <a:rPr lang="en-US" sz="2000" dirty="0"/>
              <a:t> et al., 2008)</a:t>
            </a:r>
            <a:endParaRPr lang="ar-SY" sz="2000" dirty="0"/>
          </a:p>
          <a:p>
            <a:pPr algn="just" rtl="1"/>
            <a:endParaRPr lang="ar-SY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5DA0EC8-751B-459D-9EC0-FAC57E15A3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1221" y="4491548"/>
            <a:ext cx="3576711" cy="236645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BE875DA-D2B4-4166-AC0D-A9CA500B8D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86716" y="4411096"/>
            <a:ext cx="1650412" cy="1650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90326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1A8061-5CB1-46EA-91A9-D2E7E11D02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97C07B-6FC3-47B9-8D89-5A355A5700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dirty="0"/>
              <a:t>مخطط الكلمات المفتاحية والمرادفات: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1D67AB31-10DB-4905-ABB1-F8E6918DAE4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9177729"/>
              </p:ext>
            </p:extLst>
          </p:nvPr>
        </p:nvGraphicFramePr>
        <p:xfrm>
          <a:off x="1905391" y="2539853"/>
          <a:ext cx="8128000" cy="2544559"/>
        </p:xfrm>
        <a:graphic>
          <a:graphicData uri="http://schemas.openxmlformats.org/drawingml/2006/table">
            <a:tbl>
              <a:tblPr rtl="1" firstRow="1" bandRow="1">
                <a:tableStyleId>{5C22544A-7EE6-4342-B048-85BDC9FD1C3A}</a:tableStyleId>
              </a:tblPr>
              <a:tblGrid>
                <a:gridCol w="1625600">
                  <a:extLst>
                    <a:ext uri="{9D8B030D-6E8A-4147-A177-3AD203B41FA5}">
                      <a16:colId xmlns:a16="http://schemas.microsoft.com/office/drawing/2014/main" val="3576763640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3498348837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772052825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446360545"/>
                    </a:ext>
                  </a:extLst>
                </a:gridCol>
                <a:gridCol w="1625600">
                  <a:extLst>
                    <a:ext uri="{9D8B030D-6E8A-4147-A177-3AD203B41FA5}">
                      <a16:colId xmlns:a16="http://schemas.microsoft.com/office/drawing/2014/main" val="2706605724"/>
                    </a:ext>
                  </a:extLst>
                </a:gridCol>
              </a:tblGrid>
              <a:tr h="605970"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Time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Outcome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Comparison 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Intervention</a:t>
                      </a:r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1"/>
                      <a:r>
                        <a:rPr lang="en-US" dirty="0"/>
                        <a:t>Patient/ Problem</a:t>
                      </a:r>
                      <a:endParaRPr lang="ar-SY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3870450"/>
                  </a:ext>
                </a:extLst>
              </a:tr>
              <a:tr h="1904479">
                <a:tc>
                  <a:txBody>
                    <a:bodyPr/>
                    <a:lstStyle/>
                    <a:p>
                      <a:pPr marL="0" marR="0" lvl="0" indent="0" algn="l" defTabSz="914400" rtl="1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 over ten years</a:t>
                      </a:r>
                    </a:p>
                    <a:p>
                      <a:pPr marL="0" marR="0" lvl="0" indent="0" algn="l" defTabSz="914400" rtl="1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 decade</a:t>
                      </a:r>
                    </a:p>
                    <a:p>
                      <a:pPr rtl="1"/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>
                        <a:buFontTx/>
                        <a:buNone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 Develop breast cancer</a:t>
                      </a:r>
                    </a:p>
                    <a:p>
                      <a:pPr marL="0" indent="0">
                        <a:buFontTx/>
                        <a:buNone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 Malignant tumor in the Breast</a:t>
                      </a:r>
                    </a:p>
                    <a:p>
                      <a:pPr rtl="1"/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>
                        <a:buFontTx/>
                        <a:buNone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 Female non smokers without daily smoke exposure.</a:t>
                      </a:r>
                    </a:p>
                    <a:p>
                      <a:pPr rtl="1"/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800" b="0" i="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rtl="1"/>
                      <a:endParaRPr lang="ar-SY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indent="0">
                        <a:buFontTx/>
                        <a:buNone/>
                      </a:pP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 Female non smokers with daily second hand smoke exposure.</a:t>
                      </a:r>
                      <a:endParaRPr lang="ar-SY" sz="1800" b="0" i="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81786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19251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C943AE-CCB6-4621-B118-691E17A19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E66479-7674-42F1-AFC0-B26FCD8B53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en-US" dirty="0"/>
              <a:t> Boolean</a:t>
            </a:r>
            <a:r>
              <a:rPr lang="ar-SY" dirty="0"/>
              <a:t>(منطق الجمع)</a:t>
            </a:r>
          </a:p>
          <a:p>
            <a:pPr algn="just" rtl="1"/>
            <a:r>
              <a:rPr lang="ar-SY" dirty="0"/>
              <a:t>تفهم معظم قواعد البيانات ومحركات البحث ثلاثة على الأقل من الأوامر التنفيذية:</a:t>
            </a:r>
          </a:p>
          <a:p>
            <a:pPr marL="0" indent="0" algn="just" rtl="1">
              <a:buNone/>
            </a:pPr>
            <a:r>
              <a:rPr lang="ar-SY" dirty="0"/>
              <a:t> </a:t>
            </a:r>
            <a:r>
              <a:rPr lang="en-US" dirty="0"/>
              <a:t>AND ، OR ، NOT</a:t>
            </a:r>
          </a:p>
          <a:p>
            <a:pPr algn="just" rtl="1"/>
            <a:r>
              <a:rPr lang="ar-SY" dirty="0"/>
              <a:t>الأمر التنفيذي هو كلمة تقرأ على أنها أمر </a:t>
            </a:r>
            <a:r>
              <a:rPr lang="ar-SY" dirty="0">
                <a:solidFill>
                  <a:srgbClr val="FF0000"/>
                </a:solidFill>
              </a:rPr>
              <a:t>يفعله</a:t>
            </a:r>
            <a:r>
              <a:rPr lang="ar-SY" dirty="0"/>
              <a:t> المحرك، وليس ككلمة للبحث </a:t>
            </a:r>
          </a:p>
          <a:p>
            <a:pPr marL="0" indent="0" algn="just" rtl="1">
              <a:buNone/>
            </a:pPr>
            <a:endParaRPr lang="ar-SY" dirty="0"/>
          </a:p>
          <a:p>
            <a:pPr marL="0" indent="0" algn="just" rtl="1">
              <a:buNone/>
            </a:pPr>
            <a:endParaRPr lang="ar-SY" dirty="0"/>
          </a:p>
          <a:p>
            <a:pPr marL="0" indent="0" algn="just" rtl="1">
              <a:buNone/>
            </a:pPr>
            <a:endParaRPr lang="ar-SY" dirty="0"/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</a:t>
            </a:r>
            <a:r>
              <a:rPr lang="en-US" sz="2000" i="1" dirty="0">
                <a:solidFill>
                  <a:prstClr val="black"/>
                </a:solidFill>
              </a:rPr>
              <a:t>PICO Searching</a:t>
            </a:r>
            <a:r>
              <a:rPr lang="en-US" sz="2000" dirty="0">
                <a:solidFill>
                  <a:prstClr val="black"/>
                </a:solidFill>
              </a:rPr>
              <a:t>, 2021)</a:t>
            </a:r>
            <a:endParaRPr lang="ar-SY" sz="2000" dirty="0">
              <a:solidFill>
                <a:prstClr val="black"/>
              </a:solidFill>
            </a:endParaRPr>
          </a:p>
          <a:p>
            <a:pPr marL="0" indent="0" algn="just" rtl="1">
              <a:buNone/>
            </a:pPr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25006B8-5F9E-4130-91E6-8C895BC994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72" y="4445233"/>
            <a:ext cx="8571428" cy="1866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32613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E574AD-FF8D-4928-9089-26CC5C87CE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3BAFF6-0A15-4892-8B1E-9FD6A6DE89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dirty="0"/>
              <a:t>الأمر التنفيذي </a:t>
            </a:r>
            <a:r>
              <a:rPr lang="en-US" sz="3600" dirty="0"/>
              <a:t>AND</a:t>
            </a:r>
            <a:endParaRPr lang="ar-SY" sz="3600" dirty="0"/>
          </a:p>
          <a:p>
            <a:pPr algn="just" rtl="1"/>
            <a:r>
              <a:rPr lang="ar-SY" dirty="0"/>
              <a:t>يتطلب أن تحتوي النتائج على جميع المصطلحات المدمجة مع </a:t>
            </a:r>
            <a:r>
              <a:rPr lang="en-US" dirty="0"/>
              <a:t>AND</a:t>
            </a:r>
          </a:p>
          <a:p>
            <a:pPr algn="just" rtl="1"/>
            <a:r>
              <a:rPr lang="ar-SY" dirty="0"/>
              <a:t>تضييق نتائجك - كلما زاد استخدام </a:t>
            </a:r>
            <a:r>
              <a:rPr lang="en-US" dirty="0"/>
              <a:t>ANDs ، </a:t>
            </a:r>
            <a:r>
              <a:rPr lang="ar-SY" dirty="0"/>
              <a:t>قل عدد النتائج التي ستستردها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</a:t>
            </a:r>
            <a:r>
              <a:rPr lang="en-US" sz="2000" i="1" dirty="0">
                <a:solidFill>
                  <a:prstClr val="black"/>
                </a:solidFill>
              </a:rPr>
              <a:t>PICO Searching</a:t>
            </a:r>
            <a:r>
              <a:rPr lang="en-US" sz="2000" dirty="0">
                <a:solidFill>
                  <a:prstClr val="black"/>
                </a:solidFill>
              </a:rPr>
              <a:t>, 2021)</a:t>
            </a:r>
            <a:endParaRPr lang="ar-SY" sz="2000" dirty="0">
              <a:solidFill>
                <a:prstClr val="black"/>
              </a:solidFill>
            </a:endParaRP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1D78E84-B09D-4370-8694-CB5A6B5B23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0750" y="4376010"/>
            <a:ext cx="3211223" cy="1800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73309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6148B7-FD2C-40DF-940B-62F3EC1D5E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33D2A3-4FC5-4C20-AC52-D5AD9D026E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dirty="0"/>
              <a:t>الأمر التنفيذي </a:t>
            </a:r>
            <a:r>
              <a:rPr lang="en-US" sz="3600" dirty="0"/>
              <a:t>OR</a:t>
            </a:r>
            <a:endParaRPr lang="ar-SY" sz="3600" dirty="0"/>
          </a:p>
          <a:p>
            <a:pPr algn="just" rtl="1"/>
            <a:r>
              <a:rPr lang="ar-SY" dirty="0"/>
              <a:t>تحتوي النتائج على إما ، أو كليهما ، أو أي مجموعة من المصطلحات مدمجة مع "أو"</a:t>
            </a:r>
          </a:p>
          <a:p>
            <a:pPr algn="just" rtl="1"/>
            <a:r>
              <a:rPr lang="ar-SY" dirty="0"/>
              <a:t>يوسع نتائجك - استخدم </a:t>
            </a:r>
            <a:r>
              <a:rPr lang="en-US" dirty="0"/>
              <a:t>OR </a:t>
            </a:r>
            <a:r>
              <a:rPr lang="ar-SY" dirty="0"/>
              <a:t> بين المرادفات.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</a:t>
            </a:r>
            <a:r>
              <a:rPr lang="en-US" sz="2000" i="1" dirty="0">
                <a:solidFill>
                  <a:prstClr val="black"/>
                </a:solidFill>
              </a:rPr>
              <a:t>PICO Searching</a:t>
            </a:r>
            <a:r>
              <a:rPr lang="en-US" sz="2000" dirty="0">
                <a:solidFill>
                  <a:prstClr val="black"/>
                </a:solidFill>
              </a:rPr>
              <a:t>, 2021)</a:t>
            </a:r>
            <a:endParaRPr lang="ar-SY" sz="2000" dirty="0">
              <a:solidFill>
                <a:prstClr val="black"/>
              </a:solidFill>
            </a:endParaRPr>
          </a:p>
          <a:p>
            <a:pPr algn="just" rtl="1"/>
            <a:endParaRPr lang="ar-SY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E0119FA-9864-46EF-8A7E-4120CBC618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0568" y="4423654"/>
            <a:ext cx="3506617" cy="17533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40620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B0136-5C0F-47D8-8DA6-610A2B04BD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بحث في مصادر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6647CE-8CEE-4B05-AEC3-48EF35BF0B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dirty="0"/>
              <a:t>الأمر التنفيذي </a:t>
            </a:r>
            <a:r>
              <a:rPr lang="en-US" sz="3600" dirty="0"/>
              <a:t>NOT</a:t>
            </a:r>
            <a:endParaRPr lang="ar-SY" sz="3600" dirty="0"/>
          </a:p>
          <a:p>
            <a:pPr algn="just" rtl="1"/>
            <a:r>
              <a:rPr lang="ar-SY" dirty="0"/>
              <a:t>لن تحتوي النتائج على أي مقالات استخدمت المصطلح (المصطلحات) المشار إليه بعد </a:t>
            </a:r>
            <a:r>
              <a:rPr lang="en-US" dirty="0"/>
              <a:t>NOT</a:t>
            </a:r>
          </a:p>
          <a:p>
            <a:pPr algn="just" rtl="1"/>
            <a:r>
              <a:rPr lang="ar-SY" dirty="0"/>
              <a:t>تضيق نتائجك 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algn="just" rtl="1"/>
            <a:endParaRPr lang="ar-SY" dirty="0"/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</a:t>
            </a:r>
            <a:r>
              <a:rPr lang="en-US" sz="2000" i="1" dirty="0">
                <a:solidFill>
                  <a:prstClr val="black"/>
                </a:solidFill>
              </a:rPr>
              <a:t>PICO Searching</a:t>
            </a:r>
            <a:r>
              <a:rPr lang="en-US" sz="2000" dirty="0">
                <a:solidFill>
                  <a:prstClr val="black"/>
                </a:solidFill>
              </a:rPr>
              <a:t>, 2021)</a:t>
            </a:r>
            <a:endParaRPr lang="ar-SY" sz="2000" dirty="0">
              <a:solidFill>
                <a:prstClr val="black"/>
              </a:solidFill>
            </a:endParaRP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5D2518F-D0F3-4732-B22B-6B40FEE400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8198" y="4299779"/>
            <a:ext cx="3563790" cy="1877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9052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2</TotalTime>
  <Words>765</Words>
  <Application>Microsoft Office PowerPoint</Application>
  <PresentationFormat>Widescreen</PresentationFormat>
  <Paragraphs>112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rial</vt:lpstr>
      <vt:lpstr>Calibri</vt:lpstr>
      <vt:lpstr>Calibri Light</vt:lpstr>
      <vt:lpstr>Simplified Arabic</vt:lpstr>
      <vt:lpstr>Office Theme</vt:lpstr>
      <vt:lpstr>الطب المسند بالدليل في ظروف العمل السريري</vt:lpstr>
      <vt:lpstr>الأهداف التعليمية:</vt:lpstr>
      <vt:lpstr>البحث في مصادر الأدلة العلمية</vt:lpstr>
      <vt:lpstr>البحث في مصادر الأدلة العلمية</vt:lpstr>
      <vt:lpstr>البحث في مصادر الأدلة العلمية</vt:lpstr>
      <vt:lpstr>البحث في مصادر الأدلة العلمية</vt:lpstr>
      <vt:lpstr>البحث في مصادر الأدلة العلمية</vt:lpstr>
      <vt:lpstr>البحث في مصادر الأدلة العلمية</vt:lpstr>
      <vt:lpstr>البحث في مصادر الأدلة العلمية</vt:lpstr>
      <vt:lpstr>البحث في مصادر الأدلة العلمية</vt:lpstr>
      <vt:lpstr>البحث في مصادر الأدلة العلمية</vt:lpstr>
      <vt:lpstr>البحث في مصادر الأدلة العلمية</vt:lpstr>
      <vt:lpstr>البحث في مصادر الأدلة العلمية</vt:lpstr>
      <vt:lpstr>PowerPoint Presentation</vt:lpstr>
      <vt:lpstr>المراجع</vt:lpstr>
    </vt:vector>
  </TitlesOfParts>
  <Company>SA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طب المسند بالدليل في ظروف العمل السريري</dc:title>
  <dc:creator>Maher Fattouh</dc:creator>
  <cp:lastModifiedBy>Yazan Kenjrawi</cp:lastModifiedBy>
  <cp:revision>41</cp:revision>
  <dcterms:created xsi:type="dcterms:W3CDTF">2021-05-07T13:07:52Z</dcterms:created>
  <dcterms:modified xsi:type="dcterms:W3CDTF">2021-06-22T11:50:45Z</dcterms:modified>
</cp:coreProperties>
</file>